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93322-A5D4-4ADA-AABD-E58FA30CDD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867511-BA96-4A9D-979A-7B4B0882EB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C3AC01-B5B9-4629-8E3D-5FD6161079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4D23C-8603-445F-983F-9A18BF265C5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7FEEED-2753-4303-BEB1-B48ADE6432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B10A40-995F-4D06-A7E6-5505449BF8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8211FB-910B-4F99-A054-48F34E3B3D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A573D8-4932-4EED-919D-FC0A1F2F39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BF1232-2952-49BC-820D-4F53CC01AC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317030-EF1C-4961-880A-99260567CD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CAEC9-24B9-481D-8485-9BFFDC0D1C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0AA5F1-417E-4031-9241-10A242B9FC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6B4B5C-2778-4E4C-BF14-B48099D5457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5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90720" y="4876920"/>
            <a:ext cx="8153280" cy="152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62120" y="5791320"/>
            <a:ext cx="7619760" cy="152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562720" y="2438280"/>
            <a:ext cx="1600200" cy="152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0" y="1050840"/>
            <a:ext cx="9524880" cy="588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10         20         30         40         50         60         70         80         90        100         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MFLIFFLFFI MFGFISGSFM FGRNFLSFWL SLVMIIFIVL CMIFSFLMVS VCLYGYYYYD FCLILMLDFC FIWLTYVCSG FYMFIMLLIN MVFCFIVFY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MFMFFFMFFF MFGFICGIFF IGRHILSFWL SVVLCIFLVM STIFSCFCLS ICIYGYCFYD FCLLIMLDFC FIWLVFYCNG FYIFILYLID IVFCFIVFY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LB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MFLLFFAIFF LFGLISGTIM LGRHFISFWQ SIMLSTFILL CVVFTYYVIG VCLYGYCYYD FCLILMLDFC FVWLTFSCSG FYLYILLLID LVFCFILFY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Esmo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MFLLFFAIFF LFGLVSGTIM LGRHFISFWQ SIILSTFILL CIVFTYYAIG VCLYGYCYYD FCLILMLDFC YIWLTFSCSG FYLYILLLID FVFCLILFY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110        120        130        140        150        160        170        180        190        200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FYYMYFDMLL GRFLIIFWIF VVCMNLFILS YDFLTAYCGW ELLGLFSFFL ISYFWYRFFA LKFGFKAFFI GKIGDVLLIF AFSIIFLSNG FCMTTFYFL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FYYMYFDMLL ARFFHIFWWF VLCMNFFILS YDFLTAYCGW ELLGLFSFFL ISYFWYRFYA LKFGFKAFFI SKVGDVLLLL VFAITFLMNG YCVITFYFL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LB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FYYMYFDIFL GRFLNIFWMF VLCMNFFILS YDFITAYCGW ELLGLYSFFL ISYFWYRFIS IKFGFKAFFI GKIGDILLIF AFSVLFSMNG YCIATFHI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Esmo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FYYMYFDIFL GRFLNIFWMF VLCMNFFILS YDFITAYCGW ELLGLYSFFK ISYFWYRF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FF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YQIRF</a:t>
            </a:r>
            <a:r>
              <a:rPr b="1" lang="en-US" sz="1000" spc="-1" strike="noStrike" u="sng">
                <a:solidFill>
                  <a:srgbClr val="ffffff"/>
                </a:solidFill>
                <a:uFillTx/>
                <a:latin typeface="Courier New"/>
                <a:ea typeface="Courier New"/>
              </a:rPr>
              <a:t>*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SIFY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R</a:t>
            </a:r>
            <a:r>
              <a:rPr b="1" lang="en-US" sz="1000" spc="-1" strike="noStrike" u="sng">
                <a:solidFill>
                  <a:srgbClr val="ffffff"/>
                </a:solidFill>
                <a:uFillTx/>
                <a:latin typeface="Courier New"/>
              </a:rPr>
              <a:t>*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NRRC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LIF AFSILFSMNG YCVATFHII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210        220        230        240        250        260        270        280        290        300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FFCMDYYYIE FSICLLVGCA FTKSTQFGLH IWLPDAMEGP IPVSALIHAA TLVVCGIILL SFVYWCFDFW FSYFYNLIGW STLILILMTL CVFYNFDVK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FLCVDYIFIV FIVFLLLTCG FTKSTQFGLH IWLPDAMEGP IPVSALIHAA TLVVCGIILI SFVFWCFDFW FCYFYSLIGW SSLILVMMSL CVFYNFDVK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LB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FLCVDYYYIA FITLILLCCA FTKSTQFGLH IWLPDAMEGP IPVSALIHAA TLVVCGIILG SFVFWCFEFW FSYFYSLICW ATAIIVLMSL CVFYNFDAK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Esmo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FLCVDYYYIA YITLILVCCA FTKSTQFGLH IWLPDAMEGP IPVSALIHAA TLVVCGIILG SFVFWCFEFW FSYFYSIICW AVGIIVLMSL CVFYNFDVK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310        320        330        340        350        360        370        380        390        400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YVAFSTICQI SFSMFCCLCI DIYIGSLFFC YHMFYKATLF IVLGIWIHIF FGLQDLRCYF FMYFCGCVLA RLLLIFAILN SCSIWFLCGF YCKDMLLAL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YVAFSTICQI SFSMFCCLSL DLYVGCLFFC YHMFYKATLF IVLGVWIHFF FGLQDVRCYF FTYFCGCILA RMLLIFAILN SCSLWFLCGF YCKDLLLCL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LB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YIAFSTICQI SFSFFCCLCL DLYVGCLFFC YHMFYKASLF IVIGIWIHIF FGLQDLRCYF FIYFCGCILA RFLLIFAILN SCSIWFLCGF YCKDMLLSM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Esmo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YIAFSTICQI SFSFFCCLCL DLYLGCLFFC YHMFYKASLF IVIGIWIHIF FGLQDLRCYF FIYFCGCILA RFLLIFAILN SCSIWFLCGF YCKDMLLSM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410        420        430        440        450        460        470        480        490        500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.ND5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MLLSFYNIIE FLFISIIFIF FTMIYNYFLL FFLMFVFKCF CLVDCLFLLF DYECCLVYCL ISLYMCILSI FFIIDFVCIF VFSSYCVFWS FFLNFYNFF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.ND5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MLTSFFFILE FLCVCLFFIF FTVIYNYFLL FFLCFVFKCF CLVDTLFLLF DFECCLVYCT FCLYMCFVLL FFVLDFLYVF IFSSYCLFWS FYLYYASFF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c.CLB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LTLAFYNIIE FLVVCIMFIF FTIIYNYFLL FFLFFVFKCF CLVDCLFLLF DFECCLVYCT LCVYMCFICI FFVLDYVYTF IYASYTTLV- FYLYFYSFF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c.Esm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LTL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FFTILNF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WLYVSYLYFL QYTIIFYYFF YFLCLS--VF AIVYFYCLIL N---VVLFIV CYVCICVLYV YFLCWTIFIH LYT-QVTLCS YFIYIFIVFL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510        520        530        540        550        560        570        580        590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.ND5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IAIFVVFLIL SVGFLYYGCL FFY-FFNIDC IMLFWRIFFV IIILVVFMIF CCWYFVCMII FMLLFVWNFV IYFRYNLKYC LFFCILWILY 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.ND5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IALFTVFIID IIKFYILSGV IFY-FFNIDC IMFFWRVFLF ITMGFLFFIF TTWYFICFYM YICMFIWNLV IYFRYNLKYC LFFCMLFIIY 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c.CLB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ITILVLFVIV MFAFIYYGST FFY-FFNTDV VMLFWRIFLI IVTLFIFSIF YCWYFLCFSI YISLFIWNFV IYFRYNLKYC LFFCILWLLY 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c.Esm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ILLYWYCLCV HLCIMEVLFL FFYGCCYVSL KSIFNYNNTV YIFDILLLIF SMFFYICIFI YL-----KFC YIFQIFKILF VFLYVMIVV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562720" y="2575080"/>
            <a:ext cx="0" cy="24444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7162920" y="2575080"/>
            <a:ext cx="0" cy="24444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990720" y="5029200"/>
            <a:ext cx="0" cy="22860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87280" y="301680"/>
            <a:ext cx="237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D5 predicted protein align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685680" y="2548080"/>
            <a:ext cx="445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smeraldo 1 nt insertion                                           1nt dele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005480" y="5011560"/>
            <a:ext cx="1788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smeraldo 1 nt dele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"/>
          <p:cNvSpPr/>
          <p:nvPr/>
        </p:nvSpPr>
        <p:spPr>
          <a:xfrm>
            <a:off x="457200" y="1670040"/>
            <a:ext cx="8255160" cy="10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            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480        490        500        510        520        530        540    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</a:rPr>
              <a:t>Esmo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   TTTTTTTTTC TATCAAATTC GGTTT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Courier New"/>
              </a:rPr>
              <a:t>TAA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AG CATTTTTTAT AGG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Courier New"/>
              </a:rPr>
              <a:t>TAA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AATA GGAGATGTAT T-CTTATAT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</a:rPr>
              <a:t>CLB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   TTTTATTT-C CATAAAATTC GGTTTTAAAG CATTTTTTAT AGGTAAAATA GGAGATATCT TGCTTATCT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</a:rPr>
              <a:t>Tb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   TTTTTTTG-C ATTAAAATTT GGTTTTAAAG CTTTTTTTAT AGGTAAAATA GGAGATGTGT TATTAATAT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</a:rPr>
              <a:t>Lt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   ATTTTATG-C ATTAAAATTT GGATTTAAAG CATTTTTTAT AAGTAAAGTA GGAGATGTAC TATTACTCT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12200" y="515880"/>
            <a:ext cx="209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D5 partial CDS alignme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57200" y="2820960"/>
            <a:ext cx="825516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210       1220       1230       1240       1250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Esmo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GCTAACATTA -TTTTTTACA ATATTA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TAG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A ATTTTTGGTT GTATGTGTCG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CLB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GTTGACATTA GCCTTTTATA ATATTATAGA ATTTTTGGTT GTATGCATC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b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GATGTTATTA TCATTTTATA ATATAATAGA ATTTTTGTTT ATAAGTATA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Lt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AATGTTAACA TCATTTTTTT TTATATTAGA ATTTTTGTGT GTATGTTTA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/>
          </p:nvPr>
        </p:nvSpPr>
        <p:spPr>
          <a:xfrm>
            <a:off x="0" y="1143000"/>
            <a:ext cx="9144000" cy="5410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10         20         30         40         50         60         70         80         90       100         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TPKKSLFLYI IHIFIFLIIY SFIILCDYTT LTLLSFDLLW LLIINLFWIT LLDSYICFIF ILLFLFCFTL FFCFLSFDTR FLFIIIIIQY IIIFLFIFI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SFQKSLFLYL IHIILFLLLY SFIILCDYTS LFYLSFDLIW LIIINIIILT ILDSYICFIF LLLFLFCFFF LFCFLNFDTR FVFMIIIMQY IIIFMFLHVI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LB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TSKILLLLYF IHIFIFLILY SFIILCDYIN VALITFDLLW LTVINGFIVL FLDSYICFIF LILFLFCFFF MFCFLTFDTR FLFMIIILQY IIIILFLFV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Esmo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en-US" sz="1000" spc="-1" strike="noStrike">
                <a:solidFill>
                  <a:srgbClr val="808080"/>
                </a:solidFill>
                <a:latin typeface="Courier New"/>
              </a:rPr>
              <a:t>NFKNPIVIVF YTHFYFFNPL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1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*</a:t>
            </a:r>
            <a:r>
              <a:rPr b="0" lang="en-US" sz="1000" spc="-1" strike="noStrike">
                <a:solidFill>
                  <a:srgbClr val="808080"/>
                </a:solidFill>
                <a:latin typeface="Courier New"/>
              </a:rPr>
              <a:t>FYY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LCDYIN ISLITFDLLW LTFINGCVVL FLDSYICFIF LILFLFCFFF MFCFLTFDTR FLFMIIIIQY IIILLFLFV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110        120        130        140        150        160        170        180        190        200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HIIIISILFE IFSLLLFLLL MSSRFGYKIL VLWYYYMLNL INFILLFILL YFMILNYCFF LCDFCFLVFD EEWLGILCLF YTLLILFKLY IAFLILFMEQ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HILFISILFE LFSLLLFLIL ISSRFGYKIL ILWYYYMINL INFILLFVLL YYMILNYCFY LCDFCFLIFD EEWLGILCLF YILLILFKLY IAILILFLEQ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LB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HIIFISILFE LFSLLLFLLL LSSRFGYKIL ILWYYYMINL INFILLFLLL YFLLLHFCFF LCDFCFLIFD EEWMGVICLF FIILILFKLY IAFLILFMEQ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Esmo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HIIFISILFE IFSLLLFLLL LSSRFGYKIL ILWYYYMINL INFILLFLLL YFLLLHFCFF LCDFCFLIFD EEWMGVLCLF FIILILFKLY IAFLVLFMEQ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210        220        230        240        250        260        270        280        290        300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LYIRLGVFIF IYMLTFYILF CFILIILLIS FIYFYILFIK LLLFQSCTCV LIGLNSFAIV SLLFVLSVNN FCFLFLIFIS TKNYIFYLYL NFHLIYSIS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LYIRLGVFIF IYMLTFYVLF CFILIILLIC FIYFYIIFIK LIIIQSITCV LIGLNSFAIV SLLFVLSVNN FSFLFLIFIS TKNYIFYMYL NFHLIYSLS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LB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LYIRLGVFVF IYMLTFYVLF CFILIILLIC LVYFYIIFIK LILLQSCTCV IIGLNSFAII SLLFVLSVNN FCFLFLIFIS TKNYIFYLYL NFHLIYSIS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Esmo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LYIRLGIFIF IYMLTFYILF CFILIILLIC LIYFYIILIK LVLLQSCTCV IIGLNSFAIM SLLFVLSVNN FCFLFLIFIS TKTYIFYLYL NFHLIYSIS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310        320        330        340        350        360        370        380        390        400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VLLIIIYYFF IIYNIFDFKY NENYFLINFI FFSFFNNFLI SLLLACLFLC IGAIPIVFGF FIKVFCLLLQ LSYLCICIGF FFIIWLIIIY IFYFRLIVNI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IILIILYYFF IVYNMFDIKY NENYFLINFI FFSFFNNLLI SIMIACIFLC IGSIPIVFGF FLKVFCLLLH LSYLGICIVF FSIIWLIIIY IFYFRLIINI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LB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CILLILYYFF LIYNIFDIKY NENYFLINFI FFSFFNNFLL SIMLSCLFLC IGTIPIAFGF FIKVFCLLTQ LSYIGVCIIL FLIIWLIIIY IFYFRLIINI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Esmo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CVLLILYYFF IIYNIFDIKY NENYFLINFI FFSFFNNFLL SIMLSCLFLC IGSIPIAFGF FIKVFCLLTQ LSYIGICIIL FLIIWLVVIY IFYFRLIINI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410        420        430        440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FIFSYQFLGF WVVKLSFINI KN-LLFFICS SVYILFFDII NLFDLI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FIFSYQFIGF WVVRLHILGF SN-LFFILSF SIFILFFDII NLFDLI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LB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FIFSYQSIGF WVVRLHLVCF NN-LIFFCSC SFYTLFFDII NLFDLI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Esmo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FIFSYQFIGF </a:t>
            </a:r>
            <a:r>
              <a:rPr b="0" lang="en-US" sz="1000" spc="-1" strike="noStrike">
                <a:solidFill>
                  <a:srgbClr val="808080"/>
                </a:solidFill>
                <a:latin typeface="Courier New"/>
              </a:rPr>
              <a:t>G</a:t>
            </a:r>
            <a:r>
              <a:rPr b="1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*</a:t>
            </a:r>
            <a:r>
              <a:rPr b="0" lang="en-US" sz="1000" spc="-1" strike="noStrike">
                <a:solidFill>
                  <a:srgbClr val="808080"/>
                </a:solidFill>
                <a:latin typeface="Courier New"/>
              </a:rPr>
              <a:t>LDFI</a:t>
            </a:r>
            <a:r>
              <a:rPr b="1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*</a:t>
            </a:r>
            <a:r>
              <a:rPr b="0" lang="en-US" sz="1000" spc="-1" strike="noStrike">
                <a:solidFill>
                  <a:srgbClr val="808080"/>
                </a:solidFill>
                <a:latin typeface="Courier New"/>
              </a:rPr>
              <a:t>SAL TI</a:t>
            </a:r>
            <a:r>
              <a:rPr b="1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*</a:t>
            </a:r>
            <a:r>
              <a:rPr b="0" lang="en-US" sz="1000" spc="-1" strike="noStrike">
                <a:solidFill>
                  <a:srgbClr val="808080"/>
                </a:solidFill>
                <a:latin typeface="Courier New"/>
              </a:rPr>
              <a:t>FFFVVAL FMHCFLILFT KLIYLI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 type="title"/>
          </p:nvPr>
        </p:nvSpPr>
        <p:spPr>
          <a:xfrm>
            <a:off x="659880" y="411120"/>
            <a:ext cx="7340760" cy="56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URF1 predicted protein align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738520" y="1905120"/>
            <a:ext cx="174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smeraldo 1nt dele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666880" y="1905120"/>
            <a:ext cx="0" cy="22860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523880" y="5257800"/>
            <a:ext cx="0" cy="22860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519560" y="5257800"/>
            <a:ext cx="174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smeraldo 1nt dele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864720" y="677880"/>
            <a:ext cx="7340760" cy="520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URF1 partial CDS alignment</a:t>
            </a: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0" y="2604960"/>
            <a:ext cx="91440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220       1230       1240       1250       1260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Esmo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ATATCAATTT ATTGG-TTTT GGG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TAA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AG ACTTCATTTA ATCTGCTTT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CLB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ATATCAATCT ATTGGATTTT GAGTAGTTAG ACTTCATTTA GTTTGCTTT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b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TTATCAATTT CTTGGTTTTT GAGTTGTAAA ATTATCTTTT ATCAATATT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Lt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TTATCAATTC ATAGGATTTT GGGTTGTGCG TCTTCATATT TTAGGATTT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0" y="1539720"/>
            <a:ext cx="9144000" cy="10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             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10         20         30         40         50         60         70         80          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</a:rPr>
              <a:t>Esmo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   TTTCAAAAAT CCTATTGTTA TTGTATTTTA TACACATTTT TATTTTTTTA ATCCTTTATA GTTTTATTAT CT-ATGTGA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</a:rPr>
              <a:t>CLB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   CTTCAAAAAT CCTATTGTTA CTATATTTTA TACATATCTT TATTTTTTTA ATACTTTATA GTTTTATTAT CTTATGTGA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</a:rPr>
              <a:t>Tb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   CCCAAAAAAT CCT--TGTTT TTATATATCA TACACATATT TATATTTCTT ATTATCTACA GCTTTATTAT CTTATGTGA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</a:rPr>
              <a:t>Lt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   CCTCAAAAAT CCT--TGTTC TTATACTTAA TTCATATAAT TTTATTTTTA TTGCTATATA GTTTTATTAT CTTATGCGA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"/>
          <p:cNvSpPr/>
          <p:nvPr/>
        </p:nvSpPr>
        <p:spPr>
          <a:xfrm>
            <a:off x="700200" y="5767560"/>
            <a:ext cx="4876560" cy="1332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7951680" y="3036960"/>
            <a:ext cx="1041480" cy="1080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685800" y="4699080"/>
            <a:ext cx="5351400" cy="279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5664240" y="4863960"/>
            <a:ext cx="3327480" cy="120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685800" y="3784680"/>
            <a:ext cx="8305920" cy="291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URF2 predicted protein align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0" y="2362320"/>
            <a:ext cx="9144000" cy="405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10         20         30         40         50         60         70         80         90        100         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MFGCFNLVLF LCFDCSRVFD LLCVRSYDFI LWWFDLDFIL YDFVFDFVVC ITFIFVFVLG FFLRIFFSFV FVLLFIVFFG LFSLSFL--Y TGYFIYYIYI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MFGCFNLVLF LCFVLSRVFD LLCIRTYDFI LWWFDLDFIL YDFVFDFVVC ITFIFIFVLG FFIRIFFSFV FVLLFITFFG ICSLTML--F TGYYIYYIYI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Esmo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MFGCFNLVLF LCFDCSRVFD LLCVRAYDFI LWWFDLDYIL YDFVFDFVVC ITFIFIFILG FFIRIFFSFV FVLLFITFFG VYALSML--Y TGYYIFYIYI</a:t>
            </a:r>
            <a:r>
              <a:rPr b="0" lang="en-US" sz="1000" spc="-1" strike="noStrike">
                <a:solidFill>
                  <a:srgbClr val="808080"/>
                </a:solidFill>
                <a:latin typeface="Courier New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LB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MFGCFNLVLF LCFDCSRVFD LLCVRAYDFI LWWFDLDYIL YDFVFDFVVC ITFIFIFILG FFVRIFFSFV FVLLFITFFG TYTLSML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YIY RLLYIL</a:t>
            </a:r>
            <a:r>
              <a:rPr b="1" lang="en-US" sz="1000" spc="-1" strike="noStrike" u="sng">
                <a:solidFill>
                  <a:srgbClr val="ffffff"/>
                </a:solidFill>
                <a:uFillTx/>
                <a:latin typeface="Courier New"/>
              </a:rPr>
              <a:t>*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HI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110        120        130        140        150        160        170        180        190        200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LYNFICYFFC F--SIALYYI EFFTYLLCFI FIDFISFSNH LISYFGIINM FNVIFCSYLF CLFYFIICFI FCFIFFVIRC LFVIIYDFLF FNFDIYISF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LYNFICFFFA FGINFLIYYI EFFIFITFHI FFDFISFSNY IYNYFGILYM FNVMFCAYLF CLFYFVIYFL FCFIFFVIRC LFIVIMDFLF FNFDIFVSI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Esmo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LYNFICFFFS H--LVSIFWY IIWNFLCLYY FIYFLTFVFH VLSIIFLVCY LHLILYFVRI CFVYFILFYF VLYFLFVVYL LYLIFY-FLI LIFSYHWRY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LB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IIFHMFLFYV RYFSDILFGI FYVYIILSVF WFYKFFMFYL FFWSILHIYH ILYVFVLLIL FYNFFFILFY IFCNTLFICN CIR---LFIF FRYFYIINV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210        220        230        240        250        260        270        280        290        300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MCDIIYIDYI CFLLIYFGFI FSFITGFFCF IFVLNYVFLV LFFVLALFFG FLFLSYGLFT FLIYYFFWLY IIYSRSCFIL LQSVVIFFKF LYFDVFFIFV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LCDIVYLDFI SLLLLYFNFI FNFIYGFFSF VIILGLLFLL LFLVINLFFG FTFLVYGIQI ILLYYVYWLY MIYSRSCYIL MPAILIFFKF IYFDVFFVFV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Esmo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TYSMI----- -LFVFYYISI ISQIS-YMAF IVLL-YDFFC YYIWYSIYIL DFFYNIWIT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TLI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YMFWIY IIYSRSCYVL MPSILIFFKF IYFDVFLIFI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LB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WCTVYR---- --FRVFLNIV FLYNKFHIWI LLFHNYIRVN FFIIIHGTFI FWFFFYNLWI NIFSDKLYIL NIYNIKLLYI NAVYFNIFVY LFWCFFNIY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310        320        330        340        350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Lt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FLLILFIICF FGFFLKDFLF LNIFFDMFSV LLIYDVNNYS AFYNSYNQFC VTQLLAVY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b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FILILFIISF FSFFLKDFLF LSLYFDIFGS LYNYDILSYS IFYYQNNQFC LTQLLSIY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Esmo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FILILFIICF FSFFLKDFLF LSLFFDIFGA LFNYDIHTYS VFYYHLHQFC IT-LLFLY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LB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en-US" sz="1000" spc="-1" strike="noStrike">
                <a:solidFill>
                  <a:srgbClr val="ffffff"/>
                </a:solidFill>
                <a:latin typeface="Courier New"/>
              </a:rPr>
              <a:t>YINFVHNMFF F-FFKRFFIF VIVFWYIWST VLRY-IHILC ILLPFTPILC NAIIISLY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562720" y="4038480"/>
            <a:ext cx="0" cy="22860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7924680" y="3124080"/>
            <a:ext cx="0" cy="22860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6138720" y="3124080"/>
            <a:ext cx="179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 Brener 4nt insertio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371600" y="4038480"/>
            <a:ext cx="0" cy="22860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368000" y="4038480"/>
            <a:ext cx="178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smeraldo 2nt inser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352760" y="4978440"/>
            <a:ext cx="316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smeraldo                      2 single nt inser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5257800" y="4952880"/>
            <a:ext cx="1440" cy="21600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6019920" y="4952880"/>
            <a:ext cx="1440" cy="24156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5613480" y="4038480"/>
            <a:ext cx="174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smeraldo 9nt dele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10-31T17:44:42Z</dcterms:created>
  <dc:creator>Campbell Lab</dc:creator>
  <dc:description/>
  <dc:language>en-US</dc:language>
  <cp:lastModifiedBy>S</cp:lastModifiedBy>
  <cp:lastPrinted>2005-11-03T21:05:48Z</cp:lastPrinted>
  <dcterms:modified xsi:type="dcterms:W3CDTF">2006-03-16T18:24:37Z</dcterms:modified>
  <cp:revision>179</cp:revision>
  <dc:subject/>
  <dc:title>PowerPoint Presentation</dc:title>
</cp:coreProperties>
</file>